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87" r:id="rId8"/>
  </p:sldIdLst>
  <p:sldSz cx="12192000" cy="6858000"/>
  <p:notesSz cx="6858000" cy="9144000"/>
  <p:defaultTextStyle>
    <a:defPPr>
      <a:defRPr lang="th-TH"/>
    </a:defPPr>
    <a:lvl1pPr marL="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732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8E091-DC41-43A9-9DC3-26A6ECEA2033}" type="datetimeFigureOut">
              <a:rPr lang="th-TH" smtClean="0"/>
              <a:t>02/11/63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AF580-A882-455A-A0D0-8DF102FB8C9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1047818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8E091-DC41-43A9-9DC3-26A6ECEA2033}" type="datetimeFigureOut">
              <a:rPr lang="th-TH" smtClean="0"/>
              <a:t>02/11/63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AF580-A882-455A-A0D0-8DF102FB8C9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9248224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8E091-DC41-43A9-9DC3-26A6ECEA2033}" type="datetimeFigureOut">
              <a:rPr lang="th-TH" smtClean="0"/>
              <a:t>02/11/63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AF580-A882-455A-A0D0-8DF102FB8C9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0170290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8E091-DC41-43A9-9DC3-26A6ECEA2033}" type="datetimeFigureOut">
              <a:rPr lang="th-TH" smtClean="0"/>
              <a:t>02/11/63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AF580-A882-455A-A0D0-8DF102FB8C9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2159401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8E091-DC41-43A9-9DC3-26A6ECEA2033}" type="datetimeFigureOut">
              <a:rPr lang="th-TH" smtClean="0"/>
              <a:t>02/11/63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AF580-A882-455A-A0D0-8DF102FB8C9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8215429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8E091-DC41-43A9-9DC3-26A6ECEA2033}" type="datetimeFigureOut">
              <a:rPr lang="th-TH" smtClean="0"/>
              <a:t>02/11/63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AF580-A882-455A-A0D0-8DF102FB8C9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1758314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8E091-DC41-43A9-9DC3-26A6ECEA2033}" type="datetimeFigureOut">
              <a:rPr lang="th-TH" smtClean="0"/>
              <a:t>02/11/63</a:t>
            </a:fld>
            <a:endParaRPr lang="th-T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AF580-A882-455A-A0D0-8DF102FB8C9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0424374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8E091-DC41-43A9-9DC3-26A6ECEA2033}" type="datetimeFigureOut">
              <a:rPr lang="th-TH" smtClean="0"/>
              <a:t>02/11/63</a:t>
            </a:fld>
            <a:endParaRPr lang="th-T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AF580-A882-455A-A0D0-8DF102FB8C9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8070123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8E091-DC41-43A9-9DC3-26A6ECEA2033}" type="datetimeFigureOut">
              <a:rPr lang="th-TH" smtClean="0"/>
              <a:t>02/11/63</a:t>
            </a:fld>
            <a:endParaRPr lang="th-T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AF580-A882-455A-A0D0-8DF102FB8C9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3304206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8E091-DC41-43A9-9DC3-26A6ECEA2033}" type="datetimeFigureOut">
              <a:rPr lang="th-TH" smtClean="0"/>
              <a:t>02/11/63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AF580-A882-455A-A0D0-8DF102FB8C9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5419957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h-T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8E091-DC41-43A9-9DC3-26A6ECEA2033}" type="datetimeFigureOut">
              <a:rPr lang="th-TH" smtClean="0"/>
              <a:t>02/11/63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AF580-A882-455A-A0D0-8DF102FB8C9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4987108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th-T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58E091-DC41-43A9-9DC3-26A6ECEA2033}" type="datetimeFigureOut">
              <a:rPr lang="th-TH" smtClean="0"/>
              <a:t>02/11/63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DAF580-A882-455A-A0D0-8DF102FB8C9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1876843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h-TH"/>
      </a:defPPr>
      <a:lvl1pPr marL="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Title 1">
            <a:extLst>
              <a:ext uri="{FF2B5EF4-FFF2-40B4-BE49-F238E27FC236}">
                <a16:creationId xmlns:a16="http://schemas.microsoft.com/office/drawing/2014/main" id="{15AE6E32-D2BB-2A42-91A5-09E2E9F33FBA}"/>
              </a:ext>
            </a:extLst>
          </p:cNvPr>
          <p:cNvSpPr txBox="1">
            <a:spLocks/>
          </p:cNvSpPr>
          <p:nvPr/>
        </p:nvSpPr>
        <p:spPr>
          <a:xfrm>
            <a:off x="274782" y="0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Rarefaction curve of pass-filter reads obtained from each sample.</a:t>
            </a:r>
          </a:p>
        </p:txBody>
      </p:sp>
      <p:pic>
        <p:nvPicPr>
          <p:cNvPr id="5" name="Picture 4"/>
          <p:cNvPicPr/>
          <p:nvPr/>
        </p:nvPicPr>
        <p:blipFill>
          <a:blip r:embed="rId2"/>
          <a:stretch>
            <a:fillRect/>
          </a:stretch>
        </p:blipFill>
        <p:spPr>
          <a:xfrm>
            <a:off x="764308" y="1690688"/>
            <a:ext cx="10410699" cy="42365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21558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 txBox="1">
            <a:spLocks/>
          </p:cNvSpPr>
          <p:nvPr/>
        </p:nvSpPr>
        <p:spPr>
          <a:xfrm>
            <a:off x="249380" y="83127"/>
            <a:ext cx="11388437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ynamic bacterial community profiles in COVID-19 patients at day 1, day 3, and day 7. </a:t>
            </a:r>
            <a:endParaRPr lang="th-TH" sz="2000" dirty="0">
              <a:latin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1018" y="965037"/>
            <a:ext cx="8361172" cy="54242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705963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41745" y="494433"/>
            <a:ext cx="10668000" cy="540039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>
              <a:lnSpc>
                <a:spcPct val="90000"/>
              </a:lnSpc>
              <a:spcBef>
                <a:spcPct val="0"/>
              </a:spcBef>
            </a:pPr>
            <a:r>
              <a:rPr lang="en-US" sz="2000" b="1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Figure S3. </a:t>
            </a:r>
            <a:r>
              <a:rPr lang="en-US" sz="20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Dynamic bacterial community profiles at the phylum level in COVID-19 patients.</a:t>
            </a:r>
            <a:endParaRPr lang="th-TH" sz="20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pic>
        <p:nvPicPr>
          <p:cNvPr id="8" name="Content Placeholder 7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5488" y="1451763"/>
            <a:ext cx="8049711" cy="5159250"/>
          </a:xfrm>
        </p:spPr>
      </p:pic>
    </p:spTree>
    <p:extLst>
      <p:ext uri="{BB962C8B-B14F-4D97-AF65-F5344CB8AC3E}">
        <p14:creationId xmlns:p14="http://schemas.microsoft.com/office/powerpoint/2010/main" val="37404434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1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29820" y="2455929"/>
            <a:ext cx="3584448" cy="2926080"/>
          </a:xfrm>
        </p:spPr>
      </p:pic>
      <p:sp>
        <p:nvSpPr>
          <p:cNvPr id="4" name="Title 1">
            <a:extLst>
              <a:ext uri="{FF2B5EF4-FFF2-40B4-BE49-F238E27FC236}">
                <a16:creationId xmlns:a16="http://schemas.microsoft.com/office/drawing/2014/main" id="{15AE6E32-D2BB-2A42-91A5-09E2E9F33FBA}"/>
              </a:ext>
            </a:extLst>
          </p:cNvPr>
          <p:cNvSpPr txBox="1">
            <a:spLocks/>
          </p:cNvSpPr>
          <p:nvPr/>
        </p:nvSpPr>
        <p:spPr>
          <a:xfrm>
            <a:off x="274781" y="0"/>
            <a:ext cx="10777531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S4.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Shannon diversity index (A) and Chao1 richness (B) representing alpha diversity of bacterial community profiles in COVID-19 patients on day 1, 3, and 7.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7316" y="2455929"/>
            <a:ext cx="3584448" cy="2926080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1339952" y="2194319"/>
            <a:ext cx="42351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th-TH" dirty="0"/>
          </a:p>
        </p:txBody>
      </p:sp>
      <p:sp>
        <p:nvSpPr>
          <p:cNvPr id="8" name="Rectangle 7"/>
          <p:cNvSpPr/>
          <p:nvPr/>
        </p:nvSpPr>
        <p:spPr>
          <a:xfrm>
            <a:off x="6060124" y="2194319"/>
            <a:ext cx="42351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th-TH" dirty="0"/>
          </a:p>
        </p:txBody>
      </p:sp>
    </p:spTree>
    <p:extLst>
      <p:ext uri="{BB962C8B-B14F-4D97-AF65-F5344CB8AC3E}">
        <p14:creationId xmlns:p14="http://schemas.microsoft.com/office/powerpoint/2010/main" val="4102443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1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4413" y="1534077"/>
            <a:ext cx="2270895" cy="4351338"/>
          </a:xfrm>
        </p:spPr>
      </p:pic>
      <p:sp>
        <p:nvSpPr>
          <p:cNvPr id="7" name="Title 1">
            <a:extLst>
              <a:ext uri="{FF2B5EF4-FFF2-40B4-BE49-F238E27FC236}">
                <a16:creationId xmlns:a16="http://schemas.microsoft.com/office/drawing/2014/main" id="{15AE6E32-D2BB-2A42-91A5-09E2E9F33FBA}"/>
              </a:ext>
            </a:extLst>
          </p:cNvPr>
          <p:cNvSpPr txBox="1">
            <a:spLocks/>
          </p:cNvSpPr>
          <p:nvPr/>
        </p:nvSpPr>
        <p:spPr>
          <a:xfrm>
            <a:off x="274782" y="0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S5.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Linear discriminant analysis effect size (LEfSe) analysis of bacteria on day 1 and day 3.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9219" y="1301826"/>
            <a:ext cx="6425946" cy="48158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36274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424873" y="479220"/>
            <a:ext cx="10668000" cy="6540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>
              <a:lnSpc>
                <a:spcPct val="90000"/>
              </a:lnSpc>
              <a:spcBef>
                <a:spcPct val="0"/>
              </a:spcBef>
            </a:pP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S6.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Wilcoxon matched pairs test differential abundant of bacterial genera in each</a:t>
            </a:r>
          </a:p>
          <a:p>
            <a:pPr>
              <a:lnSpc>
                <a:spcPct val="90000"/>
              </a:lnSpc>
              <a:spcBef>
                <a:spcPct val="0"/>
              </a:spcBef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OVID-19 patients between day 1 and day 3.</a:t>
            </a:r>
            <a:endParaRPr lang="th-TH" sz="20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7508" y="1311965"/>
            <a:ext cx="5861209" cy="52874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3549146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3768" y="2078181"/>
            <a:ext cx="4383103" cy="331585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t="34498" b="-1"/>
          <a:stretch/>
        </p:blipFill>
        <p:spPr>
          <a:xfrm>
            <a:off x="6096000" y="2124362"/>
            <a:ext cx="4598493" cy="322348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447BBA9-1A61-4067-96EB-4B8BF2176534}"/>
              </a:ext>
            </a:extLst>
          </p:cNvPr>
          <p:cNvSpPr txBox="1"/>
          <p:nvPr/>
        </p:nvSpPr>
        <p:spPr>
          <a:xfrm>
            <a:off x="0" y="1658065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Figure S7a.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EAA level categorized by type of infections.</a:t>
            </a:r>
            <a:endParaRPr lang="en-US" sz="18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D68A8EB-21A7-4C67-92B5-90869EC01ACC}"/>
              </a:ext>
            </a:extLst>
          </p:cNvPr>
          <p:cNvSpPr txBox="1"/>
          <p:nvPr/>
        </p:nvSpPr>
        <p:spPr>
          <a:xfrm>
            <a:off x="5708999" y="1658065"/>
            <a:ext cx="671668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Figure S7b.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BG level (</a:t>
            </a:r>
            <a:r>
              <a:rPr lang="en-US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</a:rPr>
              <a:t>pg</a:t>
            </a:r>
            <a:r>
              <a:rPr lang="th-TH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</a:rPr>
              <a:t>/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</a:rPr>
              <a:t>mL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) categorized by type of infections.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2778000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0</TotalTime>
  <Words>156</Words>
  <Application>Microsoft Office PowerPoint</Application>
  <PresentationFormat>Widescreen</PresentationFormat>
  <Paragraphs>11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hatadon Sirivongrangson</dc:creator>
  <cp:lastModifiedBy>Phatadon Sirivongrangson</cp:lastModifiedBy>
  <cp:revision>6</cp:revision>
  <dcterms:created xsi:type="dcterms:W3CDTF">2020-06-12T03:03:57Z</dcterms:created>
  <dcterms:modified xsi:type="dcterms:W3CDTF">2020-11-02T13:03:35Z</dcterms:modified>
</cp:coreProperties>
</file>